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4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678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123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638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61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303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211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418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843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812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034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898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1E025-FF21-41D8-B9E2-DB641507254A}" type="datetimeFigureOut">
              <a:rPr lang="en-US" smtClean="0"/>
              <a:t>1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48314-160F-4A81-B837-0C2B661C3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849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VT68.2 </a:t>
            </a:r>
            <a:r>
              <a:rPr lang="en-US" dirty="0" err="1"/>
              <a:t>mAb</a:t>
            </a:r>
            <a:r>
              <a:rPr lang="en-US" dirty="0"/>
              <a:t> binds to M14 malignant melanoma and the small cell lung cancer H69 cells. </a:t>
            </a:r>
            <a:r>
              <a:rPr lang="en-US" dirty="0" smtClean="0"/>
              <a:t>For </a:t>
            </a:r>
            <a:r>
              <a:rPr lang="en-US" dirty="0"/>
              <a:t>flow cytometry, cells were detached with an enzyme-free buffer and stained with 5µg/mL of either a control Isotype antibody or VT68.2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3461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612" y="1367028"/>
            <a:ext cx="6970776" cy="41239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8517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ry Figure 1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3</dc:title>
  <dc:creator>Karbassi, Behjatolah M.</dc:creator>
  <cp:lastModifiedBy>Karbassi, Behjatolah M.</cp:lastModifiedBy>
  <cp:revision>2</cp:revision>
  <dcterms:created xsi:type="dcterms:W3CDTF">2023-01-12T21:43:12Z</dcterms:created>
  <dcterms:modified xsi:type="dcterms:W3CDTF">2023-01-14T17:45:23Z</dcterms:modified>
</cp:coreProperties>
</file>